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9"/>
  </p:notesMasterIdLst>
  <p:sldIdLst>
    <p:sldId id="256" r:id="rId2"/>
    <p:sldId id="295" r:id="rId3"/>
    <p:sldId id="259" r:id="rId4"/>
    <p:sldId id="260" r:id="rId5"/>
    <p:sldId id="261" r:id="rId6"/>
    <p:sldId id="266" r:id="rId7"/>
    <p:sldId id="294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04" autoAdjust="0"/>
    <p:restoredTop sz="75340" autoAdjust="0"/>
  </p:normalViewPr>
  <p:slideViewPr>
    <p:cSldViewPr snapToGrid="0">
      <p:cViewPr varScale="1">
        <p:scale>
          <a:sx n="86" d="100"/>
          <a:sy n="86" d="100"/>
        </p:scale>
        <p:origin x="18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0" d="100"/>
          <a:sy n="60" d="100"/>
        </p:scale>
        <p:origin x="250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37EEED-A2A1-4F92-B69F-7E64DD256FD5}" type="datetimeFigureOut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C8AFEC-13CF-4664-8592-A43FBDCDD6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7542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6649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12870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140480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43933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36728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C8AFEC-13CF-4664-8592-A43FBDCDD652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3918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BC369-5CC4-4492-A9F9-C956FEE2D3F2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633072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4D9D4-E259-4F62-A092-409385555210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2285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EA15C-BE23-4E8D-840B-D637D934EE0C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0605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ACB5-5E4D-4D15-832D-5B9C59DC3B41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418871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6BEA2-66F4-4F7A-AED6-05FF8201B978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2894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E0ACC-0176-4D75-BA65-DDE5AFB9E7B2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0163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97CAB-671B-4AB0-9C2A-696A4FAD5986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7251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C3E4A-CD6E-4F0C-B7E7-2A57BA77DE5F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122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0965-6A59-4227-BF1F-E04331F6E0AB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3278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8C1B6A-36D4-4DAA-8D5A-843DDC35C4B9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5497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B46AD-71E3-4AD0-BD68-29402943876C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0779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B0DD0-E5D4-4170-AA7E-DB20AE45F2D3}" type="datetime1">
              <a:rPr lang="ko-KR" altLang="en-US" smtClean="0"/>
              <a:t>2017-08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17282-4409-45A3-BF7A-A64374DD2A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0316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67351"/>
            <a:ext cx="9144000" cy="2028741"/>
          </a:xfrm>
        </p:spPr>
        <p:txBody>
          <a:bodyPr>
            <a:normAutofit fontScale="85000" lnSpcReduction="20000"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2014. 10. 24</a:t>
            </a:r>
          </a:p>
          <a:p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n Ja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Moon,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eon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Pyo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ong and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Weon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Young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Lee</a:t>
            </a:r>
          </a:p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Department of Preventive Medicine, College of Medicine, Chung-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University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ocal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 had been made before we started to conduct a systematic review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 anchor="ctr" anchorCtr="0">
            <a:noAutofit/>
          </a:bodyPr>
          <a:lstStyle/>
          <a:p>
            <a:r>
              <a:rPr lang="en-US" altLang="ko-KR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Protocol for a </a:t>
            </a:r>
            <a:r>
              <a:rPr lang="en-US" altLang="ko-KR" sz="3600" dirty="0">
                <a:latin typeface="Arial" panose="020B0604020202020204" pitchFamily="34" charset="0"/>
                <a:cs typeface="Arial" panose="020B0604020202020204" pitchFamily="34" charset="0"/>
              </a:rPr>
              <a:t>systematic review </a:t>
            </a:r>
            <a:r>
              <a:rPr lang="en-US" altLang="ko-KR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of reliability and </a:t>
            </a:r>
            <a:br>
              <a:rPr lang="en-US" altLang="ko-KR" sz="36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validity of the </a:t>
            </a:r>
            <a:r>
              <a:rPr lang="en-US" altLang="ko-KR" sz="3600" dirty="0" err="1">
                <a:latin typeface="Arial" panose="020B0604020202020204" pitchFamily="34" charset="0"/>
                <a:cs typeface="Arial" panose="020B0604020202020204" pitchFamily="34" charset="0"/>
              </a:rPr>
              <a:t>Morisky</a:t>
            </a:r>
            <a:r>
              <a:rPr lang="en-US" altLang="ko-KR" sz="3600" dirty="0">
                <a:latin typeface="Arial" panose="020B0604020202020204" pitchFamily="34" charset="0"/>
                <a:cs typeface="Arial" panose="020B0604020202020204" pitchFamily="34" charset="0"/>
              </a:rPr>
              <a:t> Medication Adherence </a:t>
            </a:r>
            <a:r>
              <a:rPr lang="en-US" altLang="ko-KR" sz="3600" dirty="0" smtClean="0">
                <a:latin typeface="Arial" panose="020B0604020202020204" pitchFamily="34" charset="0"/>
                <a:cs typeface="Arial" panose="020B0604020202020204" pitchFamily="34" charset="0"/>
              </a:rPr>
              <a:t>Scale-8</a:t>
            </a:r>
            <a:endParaRPr lang="ko-KR" alt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7775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49713" y="544512"/>
            <a:ext cx="10515600" cy="1325563"/>
          </a:xfrm>
        </p:spPr>
        <p:txBody>
          <a:bodyPr/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Objective (PICO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949713" y="2005012"/>
            <a:ext cx="10515600" cy="4351338"/>
          </a:xfrm>
        </p:spPr>
        <p:txBody>
          <a:bodyPr>
            <a:normAutofit lnSpcReduction="10000"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ystematic reviews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tudies which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verified the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iability and validity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MMAS-8 and showed outcome as psychometric properties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for various chronic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iseases patients.</a:t>
            </a:r>
          </a:p>
          <a:p>
            <a:endParaRPr lang="en-US" altLang="ko-KR" sz="2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iability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altLang="ko-KR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2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nternal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onsistency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lvl="2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est-retest reliability)</a:t>
            </a:r>
          </a:p>
          <a:p>
            <a:pPr lvl="1"/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Validity: </a:t>
            </a:r>
          </a:p>
          <a:p>
            <a:pPr lvl="2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riterion validity)</a:t>
            </a:r>
            <a:endParaRPr lang="en-US" altLang="ko-KR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2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onvergent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validity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lvl="2"/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onstruct validity)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2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3347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earch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algn="just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bas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election: 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lvl="1" indent="0" algn="just">
              <a:buNone/>
            </a:pP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 Medline,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mbase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, Web of science, </a:t>
            </a:r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ycInfo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&amp; ProQuest extended, CINAHL</a:t>
            </a:r>
            <a:endParaRPr lang="en-US" altLang="ko-KR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arch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trategy: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arch filters: published after 2008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the phrase “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risky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-Medication-Adherence-Scale” contained, or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“MMAS”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was combined with “8” or “eight item” 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iability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, validity, accuracy, psychometric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property-&gt;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designed to maximize sensitivity: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914400" lvl="2" indent="0" algn="just">
              <a:buNone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((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reliab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[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]) OR (valid*[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]) OR (accuracy) OR (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psychome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[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])) </a:t>
            </a:r>
            <a:endParaRPr lang="ko-KR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lvl="1" indent="0" algn="just">
              <a:buNone/>
            </a:pPr>
            <a:endParaRPr lang="en-US" altLang="ko-KR" sz="1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lvl="1" indent="0" algn="just">
              <a:buNone/>
            </a:pP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((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risky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-Medication-Adherence-Scale) OR (MMAS-8) OR (8-MMAS) OR (eight-item-MMAS) OR (8-item-MMAS) OR (8-items-MMAS) OR (MMAS-8-items) OR (eight-items-MMAS) OR (MMAS-eight-items)) AND ((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iab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*[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]) OR (valid*[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]) OR (accuracy) OR (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ychomet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*[</a:t>
            </a:r>
            <a:r>
              <a:rPr lang="en-US" altLang="ko-KR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n-US" altLang="ko-KR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]))</a:t>
            </a:r>
          </a:p>
          <a:p>
            <a:pPr algn="just"/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3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494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lection and exclusion criteri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lection criteria: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ontained phrase “MMAS-8” in manuscript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Published in English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hronic disease</a:t>
            </a:r>
          </a:p>
          <a:p>
            <a:pPr marL="457200" lvl="1" indent="0" algn="just">
              <a:buNone/>
            </a:pP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Exclusion criteria:</a:t>
            </a:r>
          </a:p>
          <a:p>
            <a:pPr lvl="1" algn="just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Not the original article</a:t>
            </a:r>
          </a:p>
          <a:p>
            <a:pPr marL="457200" lvl="1" indent="0" algn="just">
              <a:buNone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- abstract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4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4574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iability and validity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iability:</a:t>
            </a:r>
          </a:p>
          <a:p>
            <a:pPr lvl="1">
              <a:buFontTx/>
              <a:buChar char="-"/>
            </a:pP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nternal consistency:</a:t>
            </a:r>
            <a:r>
              <a:rPr lang="ko-KR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Cronbach’s alpha coefficient</a:t>
            </a:r>
          </a:p>
          <a:p>
            <a:pPr lvl="2">
              <a:buFontTx/>
              <a:buChar char="-"/>
            </a:pP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or meta-analysis</a:t>
            </a:r>
          </a:p>
          <a:p>
            <a:pPr lvl="1">
              <a:buFontTx/>
              <a:buChar char="-"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est-retest reliability: Inter-class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orrelation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oefficient(ICC)</a:t>
            </a:r>
          </a:p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alidity: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>
              <a:buFontTx/>
              <a:buChar char="-"/>
            </a:pP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riterion validity: sensitivity, specificity </a:t>
            </a:r>
          </a:p>
          <a:p>
            <a:pPr lvl="2">
              <a:buFontTx/>
              <a:buChar char="-"/>
            </a:pP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For meta-analysis</a:t>
            </a:r>
          </a:p>
          <a:p>
            <a:pPr lvl="1">
              <a:buFontTx/>
              <a:buChar char="-"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onvergent validity):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pearman correlation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oefficien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, Pearson’s correlation coefficient</a:t>
            </a:r>
          </a:p>
          <a:p>
            <a:pPr lvl="1">
              <a:buFontTx/>
              <a:buChar char="-"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onstruct validity):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FA(Confirmatory factor analysis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EFA(Exploratory factor analysis) 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5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62434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Data synthesis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Internal consistency: Cronbach’s alpha coefficient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Fisher’s r-to-Z transformation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-&gt;weighted mean by sample size (Barlow et al, 2010) </a:t>
            </a:r>
          </a:p>
          <a:p>
            <a:pPr marL="914400" lvl="2" indent="0">
              <a:buNone/>
            </a:pP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riterion validity: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pooled sensitivity and specificity</a:t>
            </a:r>
          </a:p>
          <a:p>
            <a:pPr lvl="1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ut-off 6, cut-off 8</a:t>
            </a:r>
          </a:p>
          <a:p>
            <a:pPr lvl="1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pooled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ensitivity and specificity,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eterogeneity (Q-</a:t>
            </a:r>
            <a:r>
              <a:rPr lang="en-US" altLang="ko-KR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ststics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lvl="1">
              <a:buFontTx/>
              <a:buChar char="-"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nsitivity analysis: by disease</a:t>
            </a:r>
          </a:p>
          <a:p>
            <a:pPr marL="457200" lvl="1" indent="0">
              <a:buNone/>
            </a:pP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 program: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eta-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DiS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(Zamora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et al, 2006), SAS 9.2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6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68327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Quality Assessment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838200" y="1825624"/>
            <a:ext cx="10515600" cy="4831849"/>
          </a:xfrm>
        </p:spPr>
        <p:txBody>
          <a:bodyPr>
            <a:normAutofit fontScale="92500" lnSpcReduction="20000"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Quality Assessment of Diagnostic Accuracy Studies-2 (QUADAS-2)</a:t>
            </a:r>
          </a:p>
          <a:p>
            <a:pPr lvl="1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election, index, test, reference standard, slow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timing domain</a:t>
            </a:r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elat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internal validity: risk of bias)</a:t>
            </a:r>
            <a:r>
              <a:rPr lang="ko-KR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을 평가</a:t>
            </a:r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Relate to external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validity: applicability</a:t>
            </a: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Risk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of bias: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r>
              <a:rPr lang="ko-KR" altLang="en-US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200" dirty="0">
                <a:latin typeface="Arial" panose="020B0604020202020204" pitchFamily="34" charset="0"/>
                <a:cs typeface="Arial" panose="020B0604020202020204" pitchFamily="34" charset="0"/>
              </a:rPr>
              <a:t>1: Could the selection of patients have introduced bias?</a:t>
            </a:r>
            <a:endParaRPr lang="en-US" altLang="ko-KR" sz="2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r>
              <a:rPr lang="ko-KR" altLang="en-US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2200" dirty="0">
                <a:latin typeface="Arial" panose="020B0604020202020204" pitchFamily="34" charset="0"/>
                <a:cs typeface="Arial" panose="020B0604020202020204" pitchFamily="34" charset="0"/>
              </a:rPr>
              <a:t>: Could the conduct or interpretation of the index test have introduced bias</a:t>
            </a:r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?</a:t>
            </a:r>
          </a:p>
          <a:p>
            <a:pPr lvl="1"/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r>
              <a:rPr lang="ko-KR" altLang="en-US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200" dirty="0">
                <a:latin typeface="Arial" panose="020B0604020202020204" pitchFamily="34" charset="0"/>
                <a:cs typeface="Arial" panose="020B0604020202020204" pitchFamily="34" charset="0"/>
              </a:rPr>
              <a:t>3: Could the reference standard, its conduct, or its interpretation have introduced bias</a:t>
            </a:r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?</a:t>
            </a:r>
          </a:p>
          <a:p>
            <a:pPr lvl="1"/>
            <a:r>
              <a:rPr lang="en-US" altLang="ko-KR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r>
              <a:rPr lang="ko-KR" altLang="en-US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200" dirty="0">
                <a:latin typeface="Arial" panose="020B0604020202020204" pitchFamily="34" charset="0"/>
                <a:cs typeface="Arial" panose="020B0604020202020204" pitchFamily="34" charset="0"/>
              </a:rPr>
              <a:t>4: Could the patient flow have introduced bias?</a:t>
            </a:r>
            <a:endParaRPr lang="en-US" altLang="ko-KR" sz="2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Applicability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altLang="ko-KR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altLang="ko-KR" sz="19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 1: Are </a:t>
            </a:r>
            <a:r>
              <a:rPr lang="en-US" altLang="ko-KR" sz="1900" dirty="0">
                <a:latin typeface="Arial" panose="020B0604020202020204" pitchFamily="34" charset="0"/>
                <a:cs typeface="Arial" panose="020B0604020202020204" pitchFamily="34" charset="0"/>
              </a:rPr>
              <a:t>there concerns that the included patients do not match the review question?</a:t>
            </a:r>
          </a:p>
          <a:p>
            <a:pPr lvl="1"/>
            <a:r>
              <a:rPr lang="en-US" altLang="ko-KR" sz="19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 2: Are </a:t>
            </a:r>
            <a:r>
              <a:rPr lang="en-US" altLang="ko-KR" sz="1900" dirty="0">
                <a:latin typeface="Arial" panose="020B0604020202020204" pitchFamily="34" charset="0"/>
                <a:cs typeface="Arial" panose="020B0604020202020204" pitchFamily="34" charset="0"/>
              </a:rPr>
              <a:t>there concerns that the index test, its conduct, or its interpretation differ from the review question?</a:t>
            </a:r>
          </a:p>
          <a:p>
            <a:pPr lvl="1"/>
            <a:r>
              <a:rPr lang="en-US" altLang="ko-KR" sz="19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 3: Are </a:t>
            </a:r>
            <a:r>
              <a:rPr lang="en-US" altLang="ko-KR" sz="1900" dirty="0">
                <a:latin typeface="Arial" panose="020B0604020202020204" pitchFamily="34" charset="0"/>
                <a:cs typeface="Arial" panose="020B0604020202020204" pitchFamily="34" charset="0"/>
              </a:rPr>
              <a:t>there concerns that the target condition as defined by the reference standard does not match the review question?</a:t>
            </a:r>
            <a:endParaRPr lang="en-US" altLang="ko-KR" sz="2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 vert="horz" lIns="91440" tIns="45720" rIns="91440" bIns="45720" rtlCol="0" anchor="ctr"/>
          <a:lstStyle/>
          <a:p>
            <a:fld id="{B2317282-4409-45A3-BF7A-A64374DD2A83}" type="slidenum">
              <a:rPr lang="ko-KR" altLang="en-US" sz="2800" b="1">
                <a:solidFill>
                  <a:schemeClr val="tx1"/>
                </a:solidFill>
              </a:rPr>
              <a:pPr/>
              <a:t>7</a:t>
            </a:fld>
            <a:r>
              <a:rPr lang="en-US" altLang="ko-KR" sz="2800" b="1" dirty="0" smtClean="0">
                <a:solidFill>
                  <a:schemeClr val="tx1"/>
                </a:solidFill>
              </a:rPr>
              <a:t>/7</a:t>
            </a:r>
            <a:endParaRPr lang="ko-KR" altLang="en-US" sz="2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67456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0</TotalTime>
  <Words>566</Words>
  <Application>Microsoft Office PowerPoint</Application>
  <PresentationFormat>와이드스크린</PresentationFormat>
  <Paragraphs>83</Paragraphs>
  <Slides>7</Slides>
  <Notes>6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0" baseType="lpstr">
      <vt:lpstr>맑은 고딕</vt:lpstr>
      <vt:lpstr>Arial</vt:lpstr>
      <vt:lpstr>Office 테마</vt:lpstr>
      <vt:lpstr>Protocol for a systematic review of reliability and  validity of the Morisky Medication Adherence Scale-8</vt:lpstr>
      <vt:lpstr>Objective (PICO)</vt:lpstr>
      <vt:lpstr>Data search</vt:lpstr>
      <vt:lpstr>Selection and exclusion criteria</vt:lpstr>
      <vt:lpstr>Reliability and validity </vt:lpstr>
      <vt:lpstr>Data synthesis</vt:lpstr>
      <vt:lpstr>Quality Assessment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</dc:creator>
  <cp:lastModifiedBy>CAU</cp:lastModifiedBy>
  <cp:revision>222</cp:revision>
  <dcterms:created xsi:type="dcterms:W3CDTF">2014-10-19T22:02:10Z</dcterms:created>
  <dcterms:modified xsi:type="dcterms:W3CDTF">2017-08-25T11:14:20Z</dcterms:modified>
</cp:coreProperties>
</file>